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33" autoAdjust="0"/>
    <p:restoredTop sz="96076" autoAdjust="0"/>
  </p:normalViewPr>
  <p:slideViewPr>
    <p:cSldViewPr snapToGrid="0">
      <p:cViewPr>
        <p:scale>
          <a:sx n="100" d="100"/>
          <a:sy n="100" d="100"/>
        </p:scale>
        <p:origin x="1812" y="-20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02DD474C-0930-022E-C1B8-771C386E03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170" y="1064151"/>
            <a:ext cx="5740903" cy="544523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B2D3F66-9D3B-44B7-B8BC-897D14BD4ACF}"/>
              </a:ext>
            </a:extLst>
          </p:cNvPr>
          <p:cNvSpPr/>
          <p:nvPr/>
        </p:nvSpPr>
        <p:spPr>
          <a:xfrm>
            <a:off x="231034" y="7119735"/>
            <a:ext cx="622453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5: Figure S5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exudate from primary dormant seeds of different genotypes on growth of 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GB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ssicicola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t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FU/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L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eds that were first imbibed for 5d, then rinsed and dried for 2d at 44% RH, followed by 5d of imbibition in water after which exudate was harvested. A. Experimental design, the exudates were produced during a second 5-day imbibition, corresponding to the blue rectangle after 2 days drying at 43% RH in the dark at 20°C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re expressed as the normalized growth ratio between the AUC with and without exudate. Points in the box plots corresponds of the three technical replicates per biological replicates (n)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2 for H10-165; n=3 for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rvil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n=4 for all others tested genotypes. The dashed line corresponds to control growth without exudate. The star indicates a significant difference from control (t-test or Mann-Whitney test, p&lt;0.05). Different letters indicate a significant difference between genotypes (Kruskal-Wallis test, Dunn method, p&lt;0.05). G (%), germination percentage determined from n replicates of 60 seeds (+/- se)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361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20</TotalTime>
  <Words>212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12</cp:revision>
  <dcterms:created xsi:type="dcterms:W3CDTF">2023-08-10T14:53:51Z</dcterms:created>
  <dcterms:modified xsi:type="dcterms:W3CDTF">2024-01-17T14:36:04Z</dcterms:modified>
</cp:coreProperties>
</file>